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5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95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085" y="2374633"/>
            <a:ext cx="1945851" cy="31607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085" y="2776832"/>
            <a:ext cx="1945851" cy="316075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867" y="3751014"/>
            <a:ext cx="1945851" cy="316075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867" y="3263923"/>
            <a:ext cx="1945851" cy="316075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085" y="4279692"/>
            <a:ext cx="1945851" cy="316075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154" y="2329269"/>
            <a:ext cx="1962234" cy="359007"/>
          </a:xfrm>
          <a:prstGeom prst="rect">
            <a:avLst/>
          </a:prstGeom>
        </p:spPr>
      </p:pic>
      <p:pic>
        <p:nvPicPr>
          <p:cNvPr id="11" name="Grafik 10"/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1758" y="3727023"/>
            <a:ext cx="1963239" cy="35919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42431"/>
          <a:stretch/>
        </p:blipFill>
        <p:spPr>
          <a:xfrm>
            <a:off x="3091424" y="4106099"/>
            <a:ext cx="1971980" cy="1197145"/>
          </a:xfrm>
          <a:prstGeom prst="rect">
            <a:avLst/>
          </a:prstGeom>
        </p:spPr>
      </p:pic>
      <p:pic>
        <p:nvPicPr>
          <p:cNvPr id="13" name="Grafik 12"/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1654" y="3239310"/>
            <a:ext cx="1962734" cy="359190"/>
          </a:xfrm>
          <a:prstGeom prst="rect">
            <a:avLst/>
          </a:prstGeom>
        </p:spPr>
      </p:pic>
      <p:pic>
        <p:nvPicPr>
          <p:cNvPr id="14" name="Grafik 13"/>
          <p:cNvPicPr preferRelativeResize="0"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1748" y="2755172"/>
            <a:ext cx="1962734" cy="359190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12"/>
          <a:srcRect l="29750" r="28572"/>
          <a:stretch/>
        </p:blipFill>
        <p:spPr>
          <a:xfrm>
            <a:off x="5640269" y="2204758"/>
            <a:ext cx="946247" cy="2307455"/>
          </a:xfrm>
          <a:prstGeom prst="rect">
            <a:avLst/>
          </a:prstGeom>
        </p:spPr>
      </p:pic>
      <p:sp>
        <p:nvSpPr>
          <p:cNvPr id="18" name="Textfeld 17"/>
          <p:cNvSpPr txBox="1"/>
          <p:nvPr/>
        </p:nvSpPr>
        <p:spPr>
          <a:xfrm>
            <a:off x="124614" y="2818701"/>
            <a:ext cx="804547" cy="237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SD95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132576" y="3309767"/>
            <a:ext cx="804547" cy="237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GLUT2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42876" y="3780381"/>
            <a:ext cx="804547" cy="237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GLUT1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142876" y="2422859"/>
            <a:ext cx="804547" cy="237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25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AR1</a:t>
            </a:r>
            <a:endParaRPr lang="de-DE" sz="82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4889807" y="3943718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4881698" y="4067332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4869160" y="3454353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881697" y="3651157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4881697" y="3190379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4871104" y="2910043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4876843" y="2721080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876843" y="2520665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4882582" y="2331702"/>
            <a:ext cx="695351" cy="1997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0 KD</a:t>
            </a:r>
            <a:endParaRPr lang="de-DE" sz="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22587" y="1468209"/>
            <a:ext cx="19483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de-DE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2075892" y="1290595"/>
            <a:ext cx="4821079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nchez-Mendoza, et al.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-α and TLR3 activation-induced depression associated with compromised hippocampal plasticity</a:t>
            </a:r>
          </a:p>
        </p:txBody>
      </p:sp>
      <p:sp>
        <p:nvSpPr>
          <p:cNvPr id="36" name="9 CuadroTexto"/>
          <p:cNvSpPr txBox="1">
            <a:spLocks noChangeArrowheads="1"/>
          </p:cNvSpPr>
          <p:nvPr/>
        </p:nvSpPr>
        <p:spPr bwMode="auto">
          <a:xfrm>
            <a:off x="1459920" y="4744359"/>
            <a:ext cx="459061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500" b="1" dirty="0">
                <a:latin typeface="Symbol" panose="05050102010706020507" pitchFamily="18" charset="2"/>
                <a:cs typeface="Times New Roman" panose="02020603050405020304" pitchFamily="18" charset="0"/>
              </a:rPr>
              <a:t>a</a:t>
            </a:r>
            <a:endParaRPr lang="en-GB" sz="50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37" name="9 CuadroTexto"/>
          <p:cNvSpPr txBox="1">
            <a:spLocks noChangeArrowheads="1"/>
          </p:cNvSpPr>
          <p:nvPr/>
        </p:nvSpPr>
        <p:spPr bwMode="auto">
          <a:xfrm>
            <a:off x="2139839" y="4725574"/>
            <a:ext cx="60065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n-GB" sz="500" b="1" dirty="0">
                <a:latin typeface="Symbol" panose="05050102010706020507" pitchFamily="18" charset="2"/>
                <a:cs typeface="Times New Roman" panose="02020603050405020304" pitchFamily="18" charset="0"/>
              </a:rPr>
              <a:t>a/</a:t>
            </a:r>
          </a:p>
          <a:p>
            <a:pPr algn="ctr"/>
            <a:r>
              <a:rPr lang="en-GB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(I:C)</a:t>
            </a:r>
            <a:endParaRPr lang="en-GB" sz="50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38" name="9 CuadroTexto"/>
          <p:cNvSpPr txBox="1">
            <a:spLocks noChangeArrowheads="1"/>
          </p:cNvSpPr>
          <p:nvPr/>
        </p:nvSpPr>
        <p:spPr bwMode="auto">
          <a:xfrm>
            <a:off x="1780076" y="4749161"/>
            <a:ext cx="566503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y(I:C)</a:t>
            </a:r>
            <a:endParaRPr lang="en-GB" sz="50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sp>
        <p:nvSpPr>
          <p:cNvPr id="39" name="9 CuadroTexto"/>
          <p:cNvSpPr txBox="1">
            <a:spLocks noChangeArrowheads="1"/>
          </p:cNvSpPr>
          <p:nvPr/>
        </p:nvSpPr>
        <p:spPr bwMode="auto">
          <a:xfrm>
            <a:off x="1014302" y="4744359"/>
            <a:ext cx="509506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GB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  <a:endParaRPr lang="en-GB" sz="500" i="1" dirty="0">
              <a:latin typeface="Symbol" panose="05050102010706020507" pitchFamily="18" charset="2"/>
              <a:cs typeface="Times New Roman" panose="02020603050405020304" pitchFamily="18" charset="0"/>
            </a:endParaRPr>
          </a:p>
        </p:txBody>
      </p:sp>
      <p:cxnSp>
        <p:nvCxnSpPr>
          <p:cNvPr id="41" name="Gerader Verbinder 40"/>
          <p:cNvCxnSpPr/>
          <p:nvPr/>
        </p:nvCxnSpPr>
        <p:spPr>
          <a:xfrm>
            <a:off x="1111623" y="4704671"/>
            <a:ext cx="3306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/>
          <p:cNvCxnSpPr/>
          <p:nvPr/>
        </p:nvCxnSpPr>
        <p:spPr>
          <a:xfrm>
            <a:off x="1523808" y="4703992"/>
            <a:ext cx="3306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/>
          <p:cNvCxnSpPr/>
          <p:nvPr/>
        </p:nvCxnSpPr>
        <p:spPr>
          <a:xfrm>
            <a:off x="1901351" y="4703992"/>
            <a:ext cx="3306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r Verbinder 43"/>
          <p:cNvCxnSpPr/>
          <p:nvPr/>
        </p:nvCxnSpPr>
        <p:spPr>
          <a:xfrm>
            <a:off x="2274833" y="4703992"/>
            <a:ext cx="33066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>
            <a:off x="735320" y="3041375"/>
            <a:ext cx="14754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feld 46"/>
          <p:cNvSpPr txBox="1"/>
          <p:nvPr/>
        </p:nvSpPr>
        <p:spPr>
          <a:xfrm>
            <a:off x="232187" y="4267045"/>
            <a:ext cx="625923" cy="2200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30" b="1" dirty="0"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de-DE" sz="83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de-DE" sz="83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n-US" sz="83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813280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9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4</cp:revision>
  <cp:lastPrinted>2019-03-06T11:43:59Z</cp:lastPrinted>
  <dcterms:created xsi:type="dcterms:W3CDTF">2018-09-05T14:08:24Z</dcterms:created>
  <dcterms:modified xsi:type="dcterms:W3CDTF">2020-05-22T07:20:53Z</dcterms:modified>
</cp:coreProperties>
</file>